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256" r:id="rId5"/>
    <p:sldId id="258" r:id="rId6"/>
    <p:sldId id="260" r:id="rId7"/>
    <p:sldId id="259" r:id="rId8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5" autoAdjust="0"/>
    <p:restoredTop sz="84000" autoAdjust="0"/>
  </p:normalViewPr>
  <p:slideViewPr>
    <p:cSldViewPr snapToGrid="0" showGuides="1">
      <p:cViewPr varScale="1">
        <p:scale>
          <a:sx n="61" d="100"/>
          <a:sy n="61" d="100"/>
        </p:scale>
        <p:origin x="-978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47CDB6-FA57-4EA0-8514-E72D95AE63D7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90EB33-9F0C-42A2-9FE3-A02D5566A270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648598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GFP expression from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wodanis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3/09/160 containing pTM214_His-GFP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ion of GFP from pTM214_His-GFP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i="1" kern="1200" baseline="-25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c</a:t>
            </a:r>
            <a:r>
              <a:rPr lang="en-US" sz="1200" i="1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la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is induced by the addition of 0.1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PTG. RFU (Relative fluorescence unit).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nb-NO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0EB33-9F0C-42A2-9FE3-A02D5566A270}" type="slidenum">
              <a:rPr lang="nb-NO" smtClean="0"/>
              <a:pPr/>
              <a:t>2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38384955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arative expression of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ExoI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coli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wodanis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rain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3/09/160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ion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Exo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done under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coli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 20 °C for 5 hours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wodani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2 °C for 3 days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C=whole cell extract, Sol=soluble protein fraction, IMAC= Immobilized metal affinity chromatography purification fractions. Arrows are pointing to bands corresponding to the expected protein (verified by mass spectroscopy). </a:t>
            </a:r>
            <a:endParaRPr lang="nb-NO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0EB33-9F0C-42A2-9FE3-A02D5566A270}" type="slidenum">
              <a:rPr lang="nb-NO" smtClean="0"/>
              <a:pPr/>
              <a:t>3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5239095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 Activity of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vExo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activity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vExo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Mw – 55.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D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Endonuclease I from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viscosa,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monitored by adding 0.5 µL (1×) or 1 µL (2×) of enzyme to the molecular beacon substrate in a similar manner as described f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Exo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In Control 1, the enzyme was replaced with the buffer used for elution during affinity purification of the His-tagged enzymes. Activity is expressed as relative fluorescence units (RFU). In Control 2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vExo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replaced with His-purifie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hStre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nb-NO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0EB33-9F0C-42A2-9FE3-A02D5566A270}" type="slidenum">
              <a:rPr lang="nb-NO" smtClean="0"/>
              <a:pPr/>
              <a:t>4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9236411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642276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463319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529311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796777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4093881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450855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477287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004220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576139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889687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998447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627932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peik.haugen@uit.no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97902" y="542349"/>
            <a:ext cx="9538996" cy="25109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i="1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Aliivibrio wodanis</a:t>
            </a:r>
            <a:r>
              <a:rPr lang="en-US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 as </a:t>
            </a:r>
            <a:r>
              <a:rPr lang="en-US" kern="1400" spc="-50" dirty="0" smtClean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a production </a:t>
            </a:r>
            <a:r>
              <a:rPr lang="en-US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host: development of genetic tools </a:t>
            </a:r>
            <a:r>
              <a:rPr lang="en-US" kern="1400" spc="-50" dirty="0" smtClean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for expression </a:t>
            </a:r>
            <a:r>
              <a:rPr lang="en-US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of cold-active enzymes </a:t>
            </a:r>
            <a:endParaRPr lang="nb-NO" sz="2800" kern="1400" spc="-50" dirty="0" smtClean="0">
              <a:effectLst/>
              <a:latin typeface="Calibri Light" panose="020F0302020204030204" pitchFamily="34" charset="0"/>
              <a:ea typeface="MS Gothic" panose="020B0609070205080204" pitchFamily="49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nb-NO" sz="1200" dirty="0" smtClean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nb-NO" sz="1200" dirty="0" smtClean="0">
                <a:effectLst/>
                <a:latin typeface="Times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enny Johansson Söderberg</a:t>
            </a:r>
            <a:r>
              <a:rPr lang="nb-NO" sz="12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†</a:t>
            </a:r>
            <a:r>
              <a:rPr lang="nb-NO" sz="1200" dirty="0" smtClean="0">
                <a:effectLst/>
                <a:latin typeface="Times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iriam Grgic</a:t>
            </a:r>
            <a:r>
              <a:rPr lang="nb-NO" sz="12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†</a:t>
            </a:r>
            <a:r>
              <a:rPr lang="nb-NO" sz="1200" dirty="0" smtClean="0">
                <a:effectLst/>
                <a:latin typeface="Times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rik Hjerde and Peik Haugen*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nb-NO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† </a:t>
            </a:r>
            <a:r>
              <a:rPr lang="nb-NO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ibuted</a:t>
            </a:r>
            <a:r>
              <a:rPr lang="nb-NO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b-NO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qually</a:t>
            </a:r>
            <a:r>
              <a:rPr lang="nb-NO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, * </a:t>
            </a:r>
            <a:r>
              <a:rPr lang="nb-NO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</a:t>
            </a:r>
            <a:r>
              <a:rPr lang="nb-NO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b-NO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uthor</a:t>
            </a:r>
            <a:r>
              <a:rPr lang="nb-NO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nb-NO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eik.haugen@uit.no</a:t>
            </a:r>
            <a:endParaRPr lang="nb-NO" sz="11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US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Chemistry and Center for Bioinformatics (</a:t>
            </a:r>
            <a:r>
              <a:rPr lang="en-US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fB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The Norwegian Structural Biology Centre (</a:t>
            </a:r>
            <a:r>
              <a:rPr lang="en-US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rStruct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Faculty of Science and Technology, </a:t>
            </a:r>
            <a:r>
              <a:rPr lang="en-US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iT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 − The Arctic University of Norway, 9037 </a:t>
            </a:r>
            <a:r>
              <a:rPr lang="en-US" sz="11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omsø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orway</a:t>
            </a:r>
            <a:endParaRPr lang="nb-NO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nb-NO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292735" y="3298372"/>
            <a:ext cx="4422686" cy="1261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2800" dirty="0" err="1" smtClean="0"/>
              <a:t>Additional</a:t>
            </a:r>
            <a:r>
              <a:rPr lang="nb-NO" sz="2800" dirty="0" smtClean="0"/>
              <a:t> file 1</a:t>
            </a:r>
          </a:p>
          <a:p>
            <a:pPr algn="ctr"/>
            <a:endParaRPr lang="nb-NO" sz="2800" dirty="0"/>
          </a:p>
          <a:p>
            <a:pPr algn="ctr"/>
            <a:r>
              <a:rPr lang="nb-NO" sz="2000" dirty="0" smtClean="0"/>
              <a:t>(</a:t>
            </a:r>
            <a:r>
              <a:rPr lang="nb-NO" sz="2000" dirty="0" err="1" smtClean="0"/>
              <a:t>Contains</a:t>
            </a:r>
            <a:r>
              <a:rPr lang="nb-NO" sz="2000" dirty="0" smtClean="0"/>
              <a:t> </a:t>
            </a:r>
            <a:r>
              <a:rPr lang="nb-NO" sz="2000" dirty="0" err="1" smtClean="0"/>
              <a:t>Supplementary</a:t>
            </a:r>
            <a:r>
              <a:rPr lang="nb-NO" sz="2000" dirty="0" smtClean="0"/>
              <a:t> </a:t>
            </a:r>
            <a:r>
              <a:rPr lang="nb-NO" sz="2000" dirty="0" err="1" smtClean="0"/>
              <a:t>figures</a:t>
            </a:r>
            <a:r>
              <a:rPr lang="nb-NO" sz="2000" dirty="0" smtClean="0"/>
              <a:t> S1-S3)</a:t>
            </a:r>
            <a:endParaRPr lang="nb-NO" sz="2000" dirty="0"/>
          </a:p>
        </p:txBody>
      </p:sp>
    </p:spTree>
    <p:extLst>
      <p:ext uri="{BB962C8B-B14F-4D97-AF65-F5344CB8AC3E}">
        <p14:creationId xmlns:p14="http://schemas.microsoft.com/office/powerpoint/2010/main" xmlns="" val="4208939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8420" y="189571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Figure </a:t>
            </a:r>
            <a:r>
              <a:rPr lang="nb-NO" dirty="0" smtClean="0"/>
              <a:t>S1</a:t>
            </a:r>
            <a:endParaRPr lang="nb-NO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01665" y="1399592"/>
            <a:ext cx="5159983" cy="3482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289663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8420" y="189571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Figure </a:t>
            </a:r>
            <a:r>
              <a:rPr lang="nb-NO" dirty="0" smtClean="0"/>
              <a:t>S2</a:t>
            </a:r>
            <a:endParaRPr lang="nb-NO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06340" y="1797488"/>
            <a:ext cx="10157647" cy="26498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454601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8420" y="189571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Figure </a:t>
            </a:r>
            <a:r>
              <a:rPr lang="nb-NO" dirty="0" smtClean="0"/>
              <a:t>S3</a:t>
            </a:r>
            <a:endParaRPr lang="nb-NO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309878" y="1898170"/>
            <a:ext cx="10006902" cy="3061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176814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9A3D37BBF26604B8A6E8C1F4AA92A05" ma:contentTypeVersion="10" ma:contentTypeDescription="Create a new document." ma:contentTypeScope="" ma:versionID="a63259e6d06a8c8190393cb0af51e83c">
  <xsd:schema xmlns:xsd="http://www.w3.org/2001/XMLSchema" xmlns:xs="http://www.w3.org/2001/XMLSchema" xmlns:p="http://schemas.microsoft.com/office/2006/metadata/properties" xmlns:ns3="1328f99f-a13f-4795-b345-affeaad612be" xmlns:ns4="720650bc-bbbc-4080-b113-90934d1137ee" targetNamespace="http://schemas.microsoft.com/office/2006/metadata/properties" ma:root="true" ma:fieldsID="4a2b53dbaf6321235cbffabb65f7e9cf" ns3:_="" ns4:_="">
    <xsd:import namespace="1328f99f-a13f-4795-b345-affeaad612be"/>
    <xsd:import namespace="720650bc-bbbc-4080-b113-90934d1137e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328f99f-a13f-4795-b345-affeaad612b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20650bc-bbbc-4080-b113-90934d1137ee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3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0C8874A-D571-4D26-ABCE-A365CAC2F6D6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720650bc-bbbc-4080-b113-90934d1137ee"/>
    <ds:schemaRef ds:uri="http://purl.org/dc/elements/1.1/"/>
    <ds:schemaRef ds:uri="http://schemas.microsoft.com/office/2006/metadata/properties"/>
    <ds:schemaRef ds:uri="1328f99f-a13f-4795-b345-affeaad612be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340ED509-FA29-42B0-9D66-57CC76CB0AE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28f99f-a13f-4795-b345-affeaad612be"/>
    <ds:schemaRef ds:uri="720650bc-bbbc-4080-b113-90934d1137e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CB31397-9EDB-4EB2-9C09-7DD248D6116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12</TotalTime>
  <Words>254</Words>
  <Application>Microsoft Office PowerPoint</Application>
  <PresentationFormat>Custom</PresentationFormat>
  <Paragraphs>18</Paragraphs>
  <Slides>4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>UiT Norges arktiske universit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ik Haugen</dc:creator>
  <cp:lastModifiedBy>0011692</cp:lastModifiedBy>
  <cp:revision>12</cp:revision>
  <dcterms:created xsi:type="dcterms:W3CDTF">2019-01-04T09:06:53Z</dcterms:created>
  <dcterms:modified xsi:type="dcterms:W3CDTF">2019-11-02T03:53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ed372810-6bc5-4b24-a067-8742f322c238_Enabled">
    <vt:lpwstr>True</vt:lpwstr>
  </property>
  <property fmtid="{D5CDD505-2E9C-101B-9397-08002B2CF9AE}" pid="3" name="MSIP_Label_ed372810-6bc5-4b24-a067-8742f322c238_SiteId">
    <vt:lpwstr>4e7f212d-74db-4563-a57b-8ae44ed05526</vt:lpwstr>
  </property>
  <property fmtid="{D5CDD505-2E9C-101B-9397-08002B2CF9AE}" pid="4" name="MSIP_Label_ed372810-6bc5-4b24-a067-8742f322c238_Owner">
    <vt:lpwstr>pha001@uit.no</vt:lpwstr>
  </property>
  <property fmtid="{D5CDD505-2E9C-101B-9397-08002B2CF9AE}" pid="5" name="MSIP_Label_ed372810-6bc5-4b24-a067-8742f322c238_SetDate">
    <vt:lpwstr>2019-01-04T09:11:17.9011085Z</vt:lpwstr>
  </property>
  <property fmtid="{D5CDD505-2E9C-101B-9397-08002B2CF9AE}" pid="6" name="MSIP_Label_ed372810-6bc5-4b24-a067-8742f322c238_Name">
    <vt:lpwstr>Open</vt:lpwstr>
  </property>
  <property fmtid="{D5CDD505-2E9C-101B-9397-08002B2CF9AE}" pid="7" name="MSIP_Label_ed372810-6bc5-4b24-a067-8742f322c238_Application">
    <vt:lpwstr>Microsoft Azure Information Protection</vt:lpwstr>
  </property>
  <property fmtid="{D5CDD505-2E9C-101B-9397-08002B2CF9AE}" pid="8" name="MSIP_Label_ed372810-6bc5-4b24-a067-8742f322c238_Extended_MSFT_Method">
    <vt:lpwstr>Manual</vt:lpwstr>
  </property>
  <property fmtid="{D5CDD505-2E9C-101B-9397-08002B2CF9AE}" pid="9" name="Sensitivity">
    <vt:lpwstr>Open</vt:lpwstr>
  </property>
  <property fmtid="{D5CDD505-2E9C-101B-9397-08002B2CF9AE}" pid="10" name="ContentTypeId">
    <vt:lpwstr>0x01010029A3D37BBF26604B8A6E8C1F4AA92A05</vt:lpwstr>
  </property>
</Properties>
</file>